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4" r:id="rId2"/>
  </p:sldIdLst>
  <p:sldSz cx="6858000" cy="9906000" type="A4"/>
  <p:notesSz cx="9144000" cy="6858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03" autoAdjust="0"/>
    <p:restoredTop sz="94660"/>
  </p:normalViewPr>
  <p:slideViewPr>
    <p:cSldViewPr snapToGrid="0">
      <p:cViewPr varScale="1">
        <p:scale>
          <a:sx n="45" d="100"/>
          <a:sy n="45" d="100"/>
        </p:scale>
        <p:origin x="2073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E2780B-98F6-4E89-8D21-E2BC8715C1FD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E9BDBB-BAB9-462E-BB64-097690E3DC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6664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8683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3686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6858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5504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0962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4667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0988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304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302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9769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7705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D361ED-7097-4D8A-BA72-22C389D20ED7}" type="datetimeFigureOut">
              <a:rPr lang="zh-CN" altLang="en-US" smtClean="0"/>
              <a:t>2016/9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CAABE-3A4B-4518-9364-37E0A5D0C1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4889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880528" y="558826"/>
            <a:ext cx="318037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/>
          <a:p>
            <a:pPr algn="ctr"/>
            <a:r>
              <a:rPr lang="en-US" altLang="zh-CN" sz="21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1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880528" y="979410"/>
            <a:ext cx="4956425" cy="3331842"/>
            <a:chOff x="-298391" y="785794"/>
            <a:chExt cx="9299517" cy="6251385"/>
          </a:xfrm>
        </p:grpSpPr>
        <p:sp>
          <p:nvSpPr>
            <p:cNvPr id="7" name="TextBox 4"/>
            <p:cNvSpPr txBox="1"/>
            <p:nvPr/>
          </p:nvSpPr>
          <p:spPr>
            <a:xfrm>
              <a:off x="7143765" y="6170978"/>
              <a:ext cx="1857361" cy="8662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orafenib</a:t>
              </a:r>
            </a:p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+ </a:t>
              </a:r>
            </a:p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SC-J9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6"/>
            <p:cNvSpPr txBox="1"/>
            <p:nvPr/>
          </p:nvSpPr>
          <p:spPr>
            <a:xfrm>
              <a:off x="3173559" y="6170978"/>
              <a:ext cx="1744908" cy="4042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orafenib</a:t>
              </a:r>
            </a:p>
          </p:txBody>
        </p:sp>
        <p:sp>
          <p:nvSpPr>
            <p:cNvPr id="9" name="矩形 8"/>
            <p:cNvSpPr/>
            <p:nvPr/>
          </p:nvSpPr>
          <p:spPr>
            <a:xfrm>
              <a:off x="1524104" y="6170978"/>
              <a:ext cx="932592" cy="40422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>
              <a:off x="5295474" y="6170978"/>
              <a:ext cx="1539197" cy="40422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SC-J9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>
              <a:off x="-298391" y="1928801"/>
              <a:ext cx="1227052" cy="40422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oechst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>
              <a:off x="-33" y="3471779"/>
              <a:ext cx="928694" cy="40422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-106165" y="5114853"/>
              <a:ext cx="1034826" cy="40422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>
              <a:off x="3183251" y="785794"/>
              <a:ext cx="3206122" cy="46197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i67 Staining of HA22T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Picture 38" descr="E:\360云盘\文档\学术\研究生研究\性激素与肝癌\Data\Ki67 proliferation\2014-12-17 HA22T Ki67 S+J\Publish\HA22T 5J5S Hoechst 5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143768" y="1428736"/>
              <a:ext cx="1857356" cy="1398480"/>
            </a:xfrm>
            <a:prstGeom prst="rect">
              <a:avLst/>
            </a:prstGeom>
            <a:noFill/>
          </p:spPr>
        </p:pic>
        <p:pic>
          <p:nvPicPr>
            <p:cNvPr id="16" name="Picture 39" descr="E:\360云盘\文档\学术\研究生研究\性激素与肝癌\Data\Ki67 proliferation\2014-12-17 HA22T Ki67 S+J\Publish\HA22T 5J5S Ki67 5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7143768" y="3036091"/>
              <a:ext cx="1857356" cy="1398480"/>
            </a:xfrm>
            <a:prstGeom prst="rect">
              <a:avLst/>
            </a:prstGeom>
            <a:noFill/>
          </p:spPr>
        </p:pic>
        <p:pic>
          <p:nvPicPr>
            <p:cNvPr id="17" name="Picture 40" descr="E:\360云盘\文档\学术\研究生研究\性激素与肝癌\Data\Ki67 proliferation\2014-12-17 HA22T Ki67 S+J\Publish\HA22T 5J5S Merged 5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7143768" y="4643446"/>
              <a:ext cx="1857356" cy="1398480"/>
            </a:xfrm>
            <a:prstGeom prst="rect">
              <a:avLst/>
            </a:prstGeom>
            <a:noFill/>
          </p:spPr>
        </p:pic>
        <p:pic>
          <p:nvPicPr>
            <p:cNvPr id="18" name="Picture 44" descr="E:\360云盘\文档\学术\研究生研究\性激素与肝癌\Data\Ki67 proliferation\2014-12-17 HA22T Ki67 S+J\Publish\HA22T 0J5S Hoechst 4.ti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095615" y="1428736"/>
              <a:ext cx="1857356" cy="1398480"/>
            </a:xfrm>
            <a:prstGeom prst="rect">
              <a:avLst/>
            </a:prstGeom>
            <a:noFill/>
          </p:spPr>
        </p:pic>
        <p:pic>
          <p:nvPicPr>
            <p:cNvPr id="19" name="Picture 45" descr="E:\360云盘\文档\学术\研究生研究\性激素与肝癌\Data\Ki67 proliferation\2014-12-17 HA22T Ki67 S+J\Publish\HA22T 0J5S Ki67 4.tif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3095615" y="3036091"/>
              <a:ext cx="1857356" cy="1398480"/>
            </a:xfrm>
            <a:prstGeom prst="rect">
              <a:avLst/>
            </a:prstGeom>
            <a:noFill/>
          </p:spPr>
        </p:pic>
        <p:pic>
          <p:nvPicPr>
            <p:cNvPr id="20" name="Picture 46" descr="E:\360云盘\文档\学术\研究生研究\性激素与肝癌\Data\Ki67 proliferation\2014-12-17 HA22T Ki67 S+J\Publish\HA22T 0J5S Merged 4.tif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095615" y="4643446"/>
              <a:ext cx="1857356" cy="1398480"/>
            </a:xfrm>
            <a:prstGeom prst="rect">
              <a:avLst/>
            </a:prstGeom>
            <a:noFill/>
          </p:spPr>
        </p:pic>
        <p:pic>
          <p:nvPicPr>
            <p:cNvPr id="21" name="Picture 47" descr="E:\360云盘\文档\学术\研究生研究\性激素与肝癌\Data\Ki67 proliferation\2014-12-17 HA22T Ki67 S+J\Publish\HA22T 0J0S Ki67 3.tif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1071538" y="3036091"/>
              <a:ext cx="1857356" cy="1398480"/>
            </a:xfrm>
            <a:prstGeom prst="rect">
              <a:avLst/>
            </a:prstGeom>
            <a:noFill/>
          </p:spPr>
        </p:pic>
        <p:pic>
          <p:nvPicPr>
            <p:cNvPr id="22" name="Picture 48" descr="E:\360云盘\文档\学术\研究生研究\性激素与肝癌\Data\Ki67 proliferation\2014-12-17 HA22T Ki67 S+J\Publish\HA22T 0J0S Merged 3.tif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071538" y="4643446"/>
              <a:ext cx="1857356" cy="1398480"/>
            </a:xfrm>
            <a:prstGeom prst="rect">
              <a:avLst/>
            </a:prstGeom>
            <a:noFill/>
          </p:spPr>
        </p:pic>
        <p:pic>
          <p:nvPicPr>
            <p:cNvPr id="23" name="Picture 49" descr="E:\360云盘\文档\学术\研究生研究\性激素与肝癌\Data\Ki67 proliferation\2014-12-17 HA22T Ki67 S+J\Publish\HA22T 0J0S Hoechst 3.tif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071538" y="1428736"/>
              <a:ext cx="1857356" cy="1398480"/>
            </a:xfrm>
            <a:prstGeom prst="rect">
              <a:avLst/>
            </a:prstGeom>
            <a:noFill/>
          </p:spPr>
        </p:pic>
        <p:pic>
          <p:nvPicPr>
            <p:cNvPr id="24" name="Picture 50" descr="E:\360云盘\文档\学术\研究生研究\性激素与肝癌\Data\Ki67 proliferation\2014-12-17 HA22T Ki67 S+J\Publish\HA22T 5J0S Ki67 2.tif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5129254" y="3025338"/>
              <a:ext cx="1871638" cy="1409233"/>
            </a:xfrm>
            <a:prstGeom prst="rect">
              <a:avLst/>
            </a:prstGeom>
            <a:noFill/>
          </p:spPr>
        </p:pic>
        <p:pic>
          <p:nvPicPr>
            <p:cNvPr id="25" name="Picture 51" descr="E:\360云盘\文档\学术\研究生研究\性激素与肝癌\Data\Ki67 proliferation\2014-12-17 HA22T Ki67 S+J\Publish\HA22T 5J0S Merged 2.tif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5129254" y="4643446"/>
              <a:ext cx="1871638" cy="1409233"/>
            </a:xfrm>
            <a:prstGeom prst="rect">
              <a:avLst/>
            </a:prstGeom>
            <a:noFill/>
          </p:spPr>
        </p:pic>
        <p:pic>
          <p:nvPicPr>
            <p:cNvPr id="26" name="Picture 52" descr="E:\360云盘\文档\学术\研究生研究\性激素与肝癌\Data\Ki67 proliferation\2014-12-17 HA22T Ki67 S+J\Publish\HA22T 5J0S Hoechst 2.tif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5129254" y="1428736"/>
              <a:ext cx="1871638" cy="1409233"/>
            </a:xfrm>
            <a:prstGeom prst="rect">
              <a:avLst/>
            </a:prstGeom>
            <a:noFill/>
          </p:spPr>
        </p:pic>
      </p:grpSp>
      <p:grpSp>
        <p:nvGrpSpPr>
          <p:cNvPr id="28" name="组合 27"/>
          <p:cNvGrpSpPr/>
          <p:nvPr/>
        </p:nvGrpSpPr>
        <p:grpSpPr>
          <a:xfrm>
            <a:off x="804378" y="5120892"/>
            <a:ext cx="4956425" cy="3331842"/>
            <a:chOff x="4278" y="4202350"/>
            <a:chExt cx="4956425" cy="3331842"/>
          </a:xfrm>
        </p:grpSpPr>
        <p:sp>
          <p:nvSpPr>
            <p:cNvPr id="29" name="TextBox 4"/>
            <p:cNvSpPr txBox="1"/>
            <p:nvPr/>
          </p:nvSpPr>
          <p:spPr>
            <a:xfrm>
              <a:off x="3970773" y="7072527"/>
              <a:ext cx="98993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orafenib</a:t>
              </a:r>
            </a:p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+ </a:t>
              </a:r>
            </a:p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SC-J9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6"/>
            <p:cNvSpPr txBox="1"/>
            <p:nvPr/>
          </p:nvSpPr>
          <p:spPr>
            <a:xfrm>
              <a:off x="1854746" y="7072527"/>
              <a:ext cx="9299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orafenib</a:t>
              </a:r>
            </a:p>
          </p:txBody>
        </p:sp>
        <p:sp>
          <p:nvSpPr>
            <p:cNvPr id="31" name="矩形 30"/>
            <p:cNvSpPr/>
            <p:nvPr/>
          </p:nvSpPr>
          <p:spPr>
            <a:xfrm>
              <a:off x="975625" y="7072527"/>
              <a:ext cx="49705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>
              <a:off x="2985677" y="7072527"/>
              <a:ext cx="820356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altLang="zh-CN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SC-J9 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矩形 32"/>
            <p:cNvSpPr/>
            <p:nvPr/>
          </p:nvSpPr>
          <p:spPr>
            <a:xfrm>
              <a:off x="4278" y="4811546"/>
              <a:ext cx="65399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oechst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矩形 33"/>
            <p:cNvSpPr/>
            <p:nvPr/>
          </p:nvSpPr>
          <p:spPr>
            <a:xfrm>
              <a:off x="163296" y="5633917"/>
              <a:ext cx="494972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矩形 34"/>
            <p:cNvSpPr/>
            <p:nvPr/>
          </p:nvSpPr>
          <p:spPr>
            <a:xfrm>
              <a:off x="106730" y="6509637"/>
              <a:ext cx="551538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35"/>
            <p:cNvSpPr/>
            <p:nvPr/>
          </p:nvSpPr>
          <p:spPr>
            <a:xfrm>
              <a:off x="1859912" y="4202350"/>
              <a:ext cx="170878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i67 Staining of SKhep1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7" name="组合 36"/>
            <p:cNvGrpSpPr/>
            <p:nvPr/>
          </p:nvGrpSpPr>
          <p:grpSpPr>
            <a:xfrm>
              <a:off x="734418" y="4503557"/>
              <a:ext cx="4226284" cy="2476164"/>
              <a:chOff x="1071538" y="1428736"/>
              <a:chExt cx="7803485" cy="4572032"/>
            </a:xfrm>
          </p:grpSpPr>
          <p:pic>
            <p:nvPicPr>
              <p:cNvPr id="38" name="Picture 2" descr="E:\360云盘\文档\学术\研究生研究\性激素与肝癌\Data\Ki67 proliferation\2014-12-22 SKhep1 Ki67 S+J\publish\SK 0J0S Hoechst 1.tif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1071538" y="1428736"/>
                <a:ext cx="1802693" cy="1357322"/>
              </a:xfrm>
              <a:prstGeom prst="rect">
                <a:avLst/>
              </a:prstGeom>
              <a:noFill/>
            </p:spPr>
          </p:pic>
          <p:pic>
            <p:nvPicPr>
              <p:cNvPr id="39" name="Picture 3" descr="E:\360云盘\文档\学术\研究生研究\性激素与肝癌\Data\Ki67 proliferation\2014-12-22 SKhep1 Ki67 S+J\publish\SK 0J0S Ki67 1.tif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1071538" y="3036091"/>
                <a:ext cx="1802693" cy="1357322"/>
              </a:xfrm>
              <a:prstGeom prst="rect">
                <a:avLst/>
              </a:prstGeom>
              <a:noFill/>
            </p:spPr>
          </p:pic>
          <p:pic>
            <p:nvPicPr>
              <p:cNvPr id="40" name="Picture 4" descr="E:\360云盘\文档\学术\研究生研究\性激素与肝癌\Data\Ki67 proliferation\2014-12-22 SKhep1 Ki67 S+J\publish\SK 0J0S Merged 1.tif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1071538" y="4643446"/>
                <a:ext cx="1802693" cy="1357322"/>
              </a:xfrm>
              <a:prstGeom prst="rect">
                <a:avLst/>
              </a:prstGeom>
              <a:noFill/>
            </p:spPr>
          </p:pic>
          <p:pic>
            <p:nvPicPr>
              <p:cNvPr id="41" name="Picture 5" descr="E:\360云盘\文档\学术\研究生研究\性激素与肝癌\Data\Ki67 proliferation\2014-12-22 SKhep1 Ki67 S+J\publish\SK 0J5S Hoechst 3.tif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3071802" y="1428736"/>
                <a:ext cx="1802693" cy="1357322"/>
              </a:xfrm>
              <a:prstGeom prst="rect">
                <a:avLst/>
              </a:prstGeom>
              <a:noFill/>
            </p:spPr>
          </p:pic>
          <p:pic>
            <p:nvPicPr>
              <p:cNvPr id="42" name="Picture 6" descr="E:\360云盘\文档\学术\研究生研究\性激素与肝癌\Data\Ki67 proliferation\2014-12-22 SKhep1 Ki67 S+J\publish\SK 0J5S Ki67 3.tif"/>
              <p:cNvPicPr>
                <a:picLocks noChangeAspect="1" noChangeArrowheads="1"/>
              </p:cNvPicPr>
              <p:nvPr/>
            </p:nvPicPr>
            <p:blipFill>
              <a:blip r:embed="rId18" cstate="print"/>
              <a:srcRect/>
              <a:stretch>
                <a:fillRect/>
              </a:stretch>
            </p:blipFill>
            <p:spPr bwMode="auto">
              <a:xfrm>
                <a:off x="3071802" y="3036091"/>
                <a:ext cx="1802693" cy="1357322"/>
              </a:xfrm>
              <a:prstGeom prst="rect">
                <a:avLst/>
              </a:prstGeom>
              <a:noFill/>
            </p:spPr>
          </p:pic>
          <p:pic>
            <p:nvPicPr>
              <p:cNvPr id="43" name="Picture 7" descr="E:\360云盘\文档\学术\研究生研究\性激素与肝癌\Data\Ki67 proliferation\2014-12-22 SKhep1 Ki67 S+J\publish\SK 0J5S Merged 3.tif"/>
              <p:cNvPicPr>
                <a:picLocks noChangeAspect="1" noChangeArrowheads="1"/>
              </p:cNvPicPr>
              <p:nvPr/>
            </p:nvPicPr>
            <p:blipFill>
              <a:blip r:embed="rId19" cstate="print"/>
              <a:srcRect/>
              <a:stretch>
                <a:fillRect/>
              </a:stretch>
            </p:blipFill>
            <p:spPr bwMode="auto">
              <a:xfrm>
                <a:off x="3071802" y="4643446"/>
                <a:ext cx="1802693" cy="1357322"/>
              </a:xfrm>
              <a:prstGeom prst="rect">
                <a:avLst/>
              </a:prstGeom>
              <a:noFill/>
            </p:spPr>
          </p:pic>
          <p:pic>
            <p:nvPicPr>
              <p:cNvPr id="44" name="Picture 8" descr="E:\360云盘\文档\学术\研究生研究\性激素与肝癌\Data\Ki67 proliferation\2014-12-22 SKhep1 Ki67 S+J\publish\SK 5J0S Hoechst 3.tif"/>
              <p:cNvPicPr>
                <a:picLocks noChangeAspect="1" noChangeArrowheads="1"/>
              </p:cNvPicPr>
              <p:nvPr/>
            </p:nvPicPr>
            <p:blipFill>
              <a:blip r:embed="rId20" cstate="print"/>
              <a:srcRect/>
              <a:stretch>
                <a:fillRect/>
              </a:stretch>
            </p:blipFill>
            <p:spPr bwMode="auto">
              <a:xfrm>
                <a:off x="5072066" y="1428736"/>
                <a:ext cx="1802693" cy="1357322"/>
              </a:xfrm>
              <a:prstGeom prst="rect">
                <a:avLst/>
              </a:prstGeom>
              <a:noFill/>
            </p:spPr>
          </p:pic>
          <p:pic>
            <p:nvPicPr>
              <p:cNvPr id="45" name="Picture 9" descr="E:\360云盘\文档\学术\研究生研究\性激素与肝癌\Data\Ki67 proliferation\2014-12-22 SKhep1 Ki67 S+J\publish\SK 5J0S Ki67 3.tif"/>
              <p:cNvPicPr>
                <a:picLocks noChangeAspect="1" noChangeArrowheads="1"/>
              </p:cNvPicPr>
              <p:nvPr/>
            </p:nvPicPr>
            <p:blipFill>
              <a:blip r:embed="rId21" cstate="print"/>
              <a:srcRect/>
              <a:stretch>
                <a:fillRect/>
              </a:stretch>
            </p:blipFill>
            <p:spPr bwMode="auto">
              <a:xfrm>
                <a:off x="5072066" y="3036091"/>
                <a:ext cx="1802693" cy="1357322"/>
              </a:xfrm>
              <a:prstGeom prst="rect">
                <a:avLst/>
              </a:prstGeom>
              <a:noFill/>
            </p:spPr>
          </p:pic>
          <p:pic>
            <p:nvPicPr>
              <p:cNvPr id="46" name="Picture 10" descr="E:\360云盘\文档\学术\研究生研究\性激素与肝癌\Data\Ki67 proliferation\2014-12-22 SKhep1 Ki67 S+J\publish\SK 5J0S Merged 3.tif"/>
              <p:cNvPicPr>
                <a:picLocks noChangeAspect="1" noChangeArrowheads="1"/>
              </p:cNvPicPr>
              <p:nvPr/>
            </p:nvPicPr>
            <p:blipFill>
              <a:blip r:embed="rId22" cstate="print"/>
              <a:srcRect/>
              <a:stretch>
                <a:fillRect/>
              </a:stretch>
            </p:blipFill>
            <p:spPr bwMode="auto">
              <a:xfrm>
                <a:off x="5072066" y="4643446"/>
                <a:ext cx="1802693" cy="1357322"/>
              </a:xfrm>
              <a:prstGeom prst="rect">
                <a:avLst/>
              </a:prstGeom>
              <a:noFill/>
            </p:spPr>
          </p:pic>
          <p:pic>
            <p:nvPicPr>
              <p:cNvPr id="47" name="Picture 11" descr="E:\360云盘\文档\学术\研究生研究\性激素与肝癌\Data\Ki67 proliferation\2014-12-22 SKhep1 Ki67 S+J\publish\SK 5J5S Hoechst 3.tif"/>
              <p:cNvPicPr>
                <a:picLocks noChangeAspect="1" noChangeArrowheads="1"/>
              </p:cNvPicPr>
              <p:nvPr/>
            </p:nvPicPr>
            <p:blipFill>
              <a:blip r:embed="rId23" cstate="print"/>
              <a:srcRect/>
              <a:stretch>
                <a:fillRect/>
              </a:stretch>
            </p:blipFill>
            <p:spPr bwMode="auto">
              <a:xfrm>
                <a:off x="7072330" y="1428736"/>
                <a:ext cx="1802693" cy="1357322"/>
              </a:xfrm>
              <a:prstGeom prst="rect">
                <a:avLst/>
              </a:prstGeom>
              <a:noFill/>
            </p:spPr>
          </p:pic>
          <p:pic>
            <p:nvPicPr>
              <p:cNvPr id="48" name="Picture 12" descr="E:\360云盘\文档\学术\研究生研究\性激素与肝癌\Data\Ki67 proliferation\2014-12-22 SKhep1 Ki67 S+J\publish\SK 5J5S Ki67 3.tif"/>
              <p:cNvPicPr>
                <a:picLocks noChangeAspect="1" noChangeArrowheads="1"/>
              </p:cNvPicPr>
              <p:nvPr/>
            </p:nvPicPr>
            <p:blipFill>
              <a:blip r:embed="rId24" cstate="print"/>
              <a:srcRect/>
              <a:stretch>
                <a:fillRect/>
              </a:stretch>
            </p:blipFill>
            <p:spPr bwMode="auto">
              <a:xfrm>
                <a:off x="7072330" y="3036091"/>
                <a:ext cx="1802693" cy="1357322"/>
              </a:xfrm>
              <a:prstGeom prst="rect">
                <a:avLst/>
              </a:prstGeom>
              <a:noFill/>
            </p:spPr>
          </p:pic>
          <p:pic>
            <p:nvPicPr>
              <p:cNvPr id="49" name="Picture 13" descr="E:\360云盘\文档\学术\研究生研究\性激素与肝癌\Data\Ki67 proliferation\2014-12-22 SKhep1 Ki67 S+J\publish\SK 5J5S Merged 3.tif"/>
              <p:cNvPicPr>
                <a:picLocks noChangeAspect="1" noChangeArrowheads="1"/>
              </p:cNvPicPr>
              <p:nvPr/>
            </p:nvPicPr>
            <p:blipFill>
              <a:blip r:embed="rId25" cstate="print"/>
              <a:srcRect/>
              <a:stretch>
                <a:fillRect/>
              </a:stretch>
            </p:blipFill>
            <p:spPr bwMode="auto">
              <a:xfrm>
                <a:off x="7072330" y="4643446"/>
                <a:ext cx="1802693" cy="1357322"/>
              </a:xfrm>
              <a:prstGeom prst="rect">
                <a:avLst/>
              </a:prstGeom>
              <a:noFill/>
            </p:spPr>
          </p:pic>
        </p:grpSp>
      </p:grpSp>
      <p:sp>
        <p:nvSpPr>
          <p:cNvPr id="51" name="矩形 50"/>
          <p:cNvSpPr/>
          <p:nvPr/>
        </p:nvSpPr>
        <p:spPr>
          <a:xfrm>
            <a:off x="880528" y="4792557"/>
            <a:ext cx="318037" cy="392415"/>
          </a:xfrm>
          <a:prstGeom prst="rect">
            <a:avLst/>
          </a:prstGeom>
          <a:noFill/>
        </p:spPr>
        <p:txBody>
          <a:bodyPr wrap="none" lIns="68580" tIns="34290" rIns="68580" bIns="34290">
            <a:spAutoFit/>
          </a:bodyPr>
          <a:lstStyle/>
          <a:p>
            <a:pPr algn="ctr"/>
            <a:r>
              <a:rPr lang="en-US" altLang="zh-CN" sz="2100" dirty="0" smtClean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100" dirty="0">
              <a:ln w="0"/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标题 1"/>
          <p:cNvSpPr txBox="1">
            <a:spLocks/>
          </p:cNvSpPr>
          <p:nvPr/>
        </p:nvSpPr>
        <p:spPr>
          <a:xfrm>
            <a:off x="116632" y="128464"/>
            <a:ext cx="3037502" cy="367550"/>
          </a:xfrm>
          <a:prstGeom prst="rect">
            <a:avLst/>
          </a:prstGeom>
        </p:spPr>
        <p:txBody>
          <a:bodyPr vert="horz" lIns="68580" tIns="34290" rIns="68580" bIns="3429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2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8108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95</TotalTime>
  <Words>49</Words>
  <Application>Microsoft Office PowerPoint</Application>
  <PresentationFormat>A4 纸张(210x297 毫米)</PresentationFormat>
  <Paragraphs>2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bined therapy of Sorafenib with ASC-J9®synergisticallysuppresses the HCC progression via alteration of pSTAT3-CCL2/Bcl2 signals</dc:title>
  <dc:creator>Junjie Xu</dc:creator>
  <cp:lastModifiedBy>Junjie Xu</cp:lastModifiedBy>
  <cp:revision>100</cp:revision>
  <dcterms:created xsi:type="dcterms:W3CDTF">2015-05-20T05:34:38Z</dcterms:created>
  <dcterms:modified xsi:type="dcterms:W3CDTF">2016-09-23T03:19:57Z</dcterms:modified>
</cp:coreProperties>
</file>